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41D7D7-1690-49C9-8CB0-0439D90B204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3B3F28-D789-49E1-8F1F-F7134387980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EA9D1A-9FE7-4BB2-ABAB-A5F63357382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9F6040-1B96-473C-AA19-88BDE7DA6A2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9CDAE1-15D9-4D74-AD02-1F19ECA506C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A76EA8-90E7-4CD4-A0DE-18981F674F4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3F3B3A-27CF-4E46-A0AC-9A752F14833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CF5DF7-5174-427E-BC68-F4196B09EA6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19A95F-7575-49BC-A9FD-B23BB43DD61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51DE51-52D6-4091-A6C2-62273CE690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543396-9EE6-487C-8B00-BCA8B75331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C4D649-C24A-4D8B-9165-1EADF03992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2415110F-3D0E-43CE-9159-430C19D04858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uppierung 26"/>
          <p:cNvGrpSpPr/>
          <p:nvPr/>
        </p:nvGrpSpPr>
        <p:grpSpPr>
          <a:xfrm>
            <a:off x="185760" y="1841400"/>
            <a:ext cx="8693280" cy="3702240"/>
            <a:chOff x="185760" y="1841400"/>
            <a:chExt cx="8693280" cy="3702240"/>
          </a:xfrm>
        </p:grpSpPr>
        <p:pic>
          <p:nvPicPr>
            <p:cNvPr id="42" name="Bild 3" descr="Survive_6groups K=2.jpg"/>
            <p:cNvPicPr/>
            <p:nvPr/>
          </p:nvPicPr>
          <p:blipFill>
            <a:blip r:embed="rId1"/>
            <a:stretch/>
          </p:blipFill>
          <p:spPr>
            <a:xfrm>
              <a:off x="530280" y="2622600"/>
              <a:ext cx="8348760" cy="2319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Textfeld 4"/>
            <p:cNvSpPr/>
            <p:nvPr/>
          </p:nvSpPr>
          <p:spPr>
            <a:xfrm rot="16200000">
              <a:off x="-838080" y="3638160"/>
              <a:ext cx="23554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Inferred ancestry of Individual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Textfeld 5"/>
            <p:cNvSpPr/>
            <p:nvPr/>
          </p:nvSpPr>
          <p:spPr>
            <a:xfrm>
              <a:off x="511560" y="2837880"/>
              <a:ext cx="404640" cy="17690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1.0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0.8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0.6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0.4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0.2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0.0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Textfeld 6"/>
            <p:cNvSpPr/>
            <p:nvPr/>
          </p:nvSpPr>
          <p:spPr>
            <a:xfrm>
              <a:off x="925560" y="4657680"/>
              <a:ext cx="1283400" cy="45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Calibri"/>
                </a:rPr>
                <a:t>Short </a:t>
              </a: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survival on nettle plant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Rechteck 7"/>
            <p:cNvSpPr/>
            <p:nvPr/>
          </p:nvSpPr>
          <p:spPr>
            <a:xfrm>
              <a:off x="1954080" y="1852560"/>
              <a:ext cx="1878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800" spc="-1" strike="noStrike">
                  <a:solidFill>
                    <a:srgbClr val="000000"/>
                  </a:solidFill>
                  <a:latin typeface="Calibri"/>
                </a:rPr>
                <a:t>Bindweed animals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Textfeld 10"/>
            <p:cNvSpPr/>
            <p:nvPr/>
          </p:nvSpPr>
          <p:spPr>
            <a:xfrm>
              <a:off x="2180160" y="4677480"/>
              <a:ext cx="1283400" cy="45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Calibri"/>
                </a:rPr>
                <a:t>Long </a:t>
              </a: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survival on nettle plant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Textfeld 11"/>
            <p:cNvSpPr/>
            <p:nvPr/>
          </p:nvSpPr>
          <p:spPr>
            <a:xfrm>
              <a:off x="3359520" y="4686480"/>
              <a:ext cx="1283400" cy="641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Calibri"/>
                </a:rPr>
                <a:t>Random </a:t>
              </a: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survival on bindweed plant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Textfeld 12"/>
            <p:cNvSpPr/>
            <p:nvPr/>
          </p:nvSpPr>
          <p:spPr>
            <a:xfrm>
              <a:off x="5893560" y="4698360"/>
              <a:ext cx="1283400" cy="45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Calibri"/>
                </a:rPr>
                <a:t>Short </a:t>
              </a: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survival on bindweed plant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Textfeld 13"/>
            <p:cNvSpPr/>
            <p:nvPr/>
          </p:nvSpPr>
          <p:spPr>
            <a:xfrm>
              <a:off x="7143480" y="4698360"/>
              <a:ext cx="1283400" cy="45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Calibri"/>
                </a:rPr>
                <a:t>Long </a:t>
              </a: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survival on bindweed plant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Textfeld 14"/>
            <p:cNvSpPr/>
            <p:nvPr/>
          </p:nvSpPr>
          <p:spPr>
            <a:xfrm>
              <a:off x="4610160" y="4685760"/>
              <a:ext cx="1283400" cy="45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Calibri"/>
                </a:rPr>
                <a:t>Random </a:t>
              </a:r>
              <a:r>
                <a:rPr b="0" lang="en-GB" sz="1200" spc="-1" strike="noStrike">
                  <a:solidFill>
                    <a:srgbClr val="000000"/>
                  </a:solidFill>
                  <a:latin typeface="Calibri"/>
                </a:rPr>
                <a:t>survival on nettle plant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Gerade Verbindung 9"/>
            <p:cNvSpPr/>
            <p:nvPr/>
          </p:nvSpPr>
          <p:spPr>
            <a:xfrm flipH="1">
              <a:off x="4527360" y="1866600"/>
              <a:ext cx="1440" cy="36770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Rechteck 15"/>
            <p:cNvSpPr/>
            <p:nvPr/>
          </p:nvSpPr>
          <p:spPr>
            <a:xfrm>
              <a:off x="5559120" y="1841400"/>
              <a:ext cx="15217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800" spc="-1" strike="noStrike">
                  <a:solidFill>
                    <a:srgbClr val="000000"/>
                  </a:solidFill>
                  <a:latin typeface="Calibri"/>
                </a:rPr>
                <a:t>Nettle animals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Textfeld 16"/>
            <p:cNvSpPr/>
            <p:nvPr/>
          </p:nvSpPr>
          <p:spPr>
            <a:xfrm>
              <a:off x="1560240" y="2345400"/>
              <a:ext cx="25671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Mean proportion of membership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Textfeld 17"/>
            <p:cNvSpPr/>
            <p:nvPr/>
          </p:nvSpPr>
          <p:spPr>
            <a:xfrm>
              <a:off x="5058720" y="2343240"/>
              <a:ext cx="25671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Mean proportion of membership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Textfeld 18"/>
            <p:cNvSpPr/>
            <p:nvPr/>
          </p:nvSpPr>
          <p:spPr>
            <a:xfrm>
              <a:off x="1330200" y="2660400"/>
              <a:ext cx="586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0.874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Textfeld 19"/>
            <p:cNvSpPr/>
            <p:nvPr/>
          </p:nvSpPr>
          <p:spPr>
            <a:xfrm>
              <a:off x="2531520" y="2669040"/>
              <a:ext cx="586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0.808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Textfeld 20"/>
            <p:cNvSpPr/>
            <p:nvPr/>
          </p:nvSpPr>
          <p:spPr>
            <a:xfrm>
              <a:off x="3733200" y="2678040"/>
              <a:ext cx="586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0.784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Textfeld 21"/>
            <p:cNvSpPr/>
            <p:nvPr/>
          </p:nvSpPr>
          <p:spPr>
            <a:xfrm>
              <a:off x="4934520" y="2686680"/>
              <a:ext cx="586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0.748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Textfeld 22"/>
            <p:cNvSpPr/>
            <p:nvPr/>
          </p:nvSpPr>
          <p:spPr>
            <a:xfrm>
              <a:off x="6136200" y="2695680"/>
              <a:ext cx="586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0.830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Textfeld 23"/>
            <p:cNvSpPr/>
            <p:nvPr/>
          </p:nvSpPr>
          <p:spPr>
            <a:xfrm>
              <a:off x="7337520" y="2704320"/>
              <a:ext cx="586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Calibri"/>
                </a:rPr>
                <a:t>0.806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2" name="Textfeld 27"/>
          <p:cNvSpPr/>
          <p:nvPr/>
        </p:nvSpPr>
        <p:spPr>
          <a:xfrm>
            <a:off x="407880" y="463680"/>
            <a:ext cx="80186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Appendix S2. Genetic membership proportions of a group of </a:t>
            </a:r>
            <a:r>
              <a:rPr b="0" i="1" lang="en-GB" sz="1800" spc="-1" strike="noStrike">
                <a:solidFill>
                  <a:srgbClr val="000000"/>
                </a:solidFill>
                <a:latin typeface="Calibri"/>
              </a:rPr>
              <a:t>H. obsoletus </a:t>
            </a: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surviving short and long on alternative plants and of a random group from the own plant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8-28T19:53:01Z</dcterms:created>
  <dc:creator>Bianca &amp; Jes Johannesen</dc:creator>
  <dc:description/>
  <dc:language>en-US</dc:language>
  <cp:lastModifiedBy>Maixner, Michael</cp:lastModifiedBy>
  <dcterms:modified xsi:type="dcterms:W3CDTF">2013-09-10T17:58:13Z</dcterms:modified>
  <cp:revision>18</cp:revision>
  <dc:subject/>
  <dc:title>Folie 1</dc:title>
</cp:coreProperties>
</file>